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0" d="100"/>
          <a:sy n="100" d="100"/>
        </p:scale>
        <p:origin x="-109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berschrift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0CE84F-9477-D943-B8AF-878FF82030A0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672C4E-4C88-6844-B07D-B7FE85D21F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03478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081740-2FB3-8440-80E7-BECA5977FB27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70193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2890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2794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8641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880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9210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9021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5847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6771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8733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8022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x-none" smtClean="0"/>
              <a:t>Bild auf Platzhalter ziehen oder durch Klicken auf Symbol hinzufügen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6888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Mastertextformat bearbeiten</a:t>
            </a:r>
          </a:p>
          <a:p>
            <a:pPr lvl="1"/>
            <a:r>
              <a:rPr lang="x-none" smtClean="0"/>
              <a:t>Zweite Ebene</a:t>
            </a:r>
          </a:p>
          <a:p>
            <a:pPr lvl="2"/>
            <a:r>
              <a:rPr lang="x-none" smtClean="0"/>
              <a:t>Dritte Ebene</a:t>
            </a:r>
          </a:p>
          <a:p>
            <a:pPr lvl="3"/>
            <a:r>
              <a:rPr lang="x-none" smtClean="0"/>
              <a:t>Vierte Ebene</a:t>
            </a:r>
          </a:p>
          <a:p>
            <a:pPr lvl="4"/>
            <a:r>
              <a:rPr lang="x-non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32BBC-2F40-B245-BC6F-9E52707206C8}" type="datetimeFigureOut">
              <a:rPr lang="de-DE" smtClean="0"/>
              <a:t>31.05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A6B240-BAC0-2240-B7E7-978C7A6476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8136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7383388"/>
              </p:ext>
            </p:extLst>
          </p:nvPr>
        </p:nvGraphicFramePr>
        <p:xfrm>
          <a:off x="289999" y="872697"/>
          <a:ext cx="8225961" cy="588493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361412"/>
                <a:gridCol w="548924"/>
                <a:gridCol w="4018544"/>
                <a:gridCol w="548925"/>
                <a:gridCol w="748156"/>
              </a:tblGrid>
              <a:tr h="5368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 smtClean="0">
                          <a:solidFill>
                            <a:srgbClr val="000000"/>
                          </a:solidFill>
                        </a:rPr>
                        <a:t>Gene Set Name</a:t>
                      </a:r>
                      <a:endParaRPr lang="de-DE" sz="1000" b="1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 err="1" smtClean="0">
                          <a:solidFill>
                            <a:srgbClr val="000000"/>
                          </a:solidFill>
                        </a:rPr>
                        <a:t>Nr</a:t>
                      </a:r>
                      <a:r>
                        <a:rPr lang="de-DE" sz="1000" b="1" dirty="0" smtClean="0">
                          <a:solidFill>
                            <a:srgbClr val="000000"/>
                          </a:solidFill>
                        </a:rPr>
                        <a:t> Genes In Gene Set</a:t>
                      </a:r>
                      <a:endParaRPr lang="de-DE" sz="1000" b="1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 smtClean="0">
                          <a:solidFill>
                            <a:srgbClr val="000000"/>
                          </a:solidFill>
                        </a:rPr>
                        <a:t>Description</a:t>
                      </a:r>
                      <a:endParaRPr lang="de-DE" sz="1000" b="1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 err="1" smtClean="0">
                          <a:solidFill>
                            <a:srgbClr val="000000"/>
                          </a:solidFill>
                        </a:rPr>
                        <a:t>Nr</a:t>
                      </a:r>
                      <a:r>
                        <a:rPr lang="de-DE" sz="1000" b="1" dirty="0" smtClean="0">
                          <a:solidFill>
                            <a:srgbClr val="000000"/>
                          </a:solidFill>
                        </a:rPr>
                        <a:t> Genes In </a:t>
                      </a:r>
                      <a:r>
                        <a:rPr lang="de-DE" sz="1000" b="1" dirty="0" err="1" smtClean="0">
                          <a:solidFill>
                            <a:srgbClr val="000000"/>
                          </a:solidFill>
                        </a:rPr>
                        <a:t>Overlap</a:t>
                      </a:r>
                      <a:endParaRPr lang="de-DE" sz="1000" b="1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 smtClean="0">
                          <a:solidFill>
                            <a:srgbClr val="000000"/>
                          </a:solidFill>
                        </a:rPr>
                        <a:t>FDR </a:t>
                      </a:r>
                      <a:r>
                        <a:rPr lang="de-DE" sz="1000" b="1" dirty="0" err="1" smtClean="0">
                          <a:solidFill>
                            <a:srgbClr val="000000"/>
                          </a:solidFill>
                        </a:rPr>
                        <a:t>q.value</a:t>
                      </a:r>
                      <a:endParaRPr lang="de-DE" sz="1000" b="1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8726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EPITHELIAL_MESENCHYMAL_TRANSITION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defining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epithelial-mesenchymal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transition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,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as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in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woun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healing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,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fibrosis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an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metastasis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  <a:endParaRPr lang="de-DE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19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0.00e+00</a:t>
                      </a:r>
                      <a:endParaRPr lang="mr-IN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517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INFLAMMATORY_RESPONSE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defining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inflammatory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respons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17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0.00e+00</a:t>
                      </a:r>
                      <a:endParaRPr lang="mr-IN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507572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MYOGENESIS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289" marR="11289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encoding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components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of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bloo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coagulation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system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; also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up-regulate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in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platelets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6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0.00e+00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t-BR" sz="1000" b="0" dirty="0" smtClean="0">
                          <a:solidFill>
                            <a:srgbClr val="000000"/>
                          </a:solidFill>
                        </a:rPr>
                        <a:t>	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COAGULATION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38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Genes down-</a:t>
                      </a:r>
                      <a:r>
                        <a:rPr lang="de-DE" sz="1000" b="0" dirty="0" err="1" smtClean="0">
                          <a:solidFill>
                            <a:srgbClr val="000000"/>
                          </a:solidFill>
                        </a:rPr>
                        <a:t>regulated</a:t>
                      </a: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 in </a:t>
                      </a:r>
                      <a:r>
                        <a:rPr lang="de-DE" sz="1000" b="0" dirty="0" err="1" smtClean="0">
                          <a:solidFill>
                            <a:srgbClr val="000000"/>
                          </a:solidFill>
                        </a:rPr>
                        <a:t>response</a:t>
                      </a: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b="0" dirty="0" err="1" smtClean="0">
                          <a:solidFill>
                            <a:srgbClr val="000000"/>
                          </a:solidFill>
                        </a:rPr>
                        <a:t>to</a:t>
                      </a: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b="0" dirty="0" err="1" smtClean="0">
                          <a:solidFill>
                            <a:srgbClr val="000000"/>
                          </a:solidFill>
                        </a:rPr>
                        <a:t>ultraviolet</a:t>
                      </a: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 (UV) </a:t>
                      </a:r>
                      <a:r>
                        <a:rPr lang="de-DE" sz="1000" b="0" dirty="0" err="1" smtClean="0">
                          <a:solidFill>
                            <a:srgbClr val="000000"/>
                          </a:solidFill>
                        </a:rPr>
                        <a:t>radiation</a:t>
                      </a: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3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0.00e+00</a:t>
                      </a:r>
                      <a:endParaRPr lang="mr-IN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HYPOXIA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up-regulate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in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respons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to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low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oxygen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levels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(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hypoxia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)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4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0.00e+00</a:t>
                      </a:r>
                      <a:endParaRPr lang="mr-IN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ALLOGRAFT_REJECTION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up-regulate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during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transplant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rejection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3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1.00e-07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ESTROGEN_RESPONSE_EARLY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defining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early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respons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to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estrogen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2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7.00e-07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IL6_JAK_STAT3_SIGNALING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87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up-regulate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by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IL6 [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GeneI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=3569] via STAT3 [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GeneI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=6774], e.g.,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during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acut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phas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respons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8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3.40e-06</a:t>
                      </a:r>
                      <a:endParaRPr lang="mr-IN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KRAS_SIGNALING_UP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up-regulate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by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KRA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activation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1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4.20e-06</a:t>
                      </a:r>
                    </a:p>
                    <a:p>
                      <a:pPr algn="ctr"/>
                      <a:endParaRPr lang="mr-IN" sz="1000" b="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TNFA_SIGNALING_VIA_NFKB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regulate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by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NF-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kB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in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respons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to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TNF [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GeneI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=7124].</a:t>
                      </a:r>
                      <a:endParaRPr lang="de-DE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1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4.20e-06</a:t>
                      </a:r>
                      <a:endParaRPr lang="mr-IN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COMPLEMENT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encoding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components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of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th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complement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system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,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which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is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part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of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th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innat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immune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system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2.26e-05</a:t>
                      </a:r>
                      <a:endParaRPr lang="mr-IN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HEME_METABOLISM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involve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in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metabolism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of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heme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(a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cofactor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consisting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of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iron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an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porphyrin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)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an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erythroblast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differentiation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2.26e-05</a:t>
                      </a:r>
                    </a:p>
                    <a:p>
                      <a:pPr algn="ctr"/>
                      <a:endParaRPr lang="mr-IN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HALLMARK_APOPTOSIS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61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Genes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mediating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programmed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cell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death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(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apoptosis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)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by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activation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of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de-DE" sz="1000" dirty="0" err="1" smtClean="0">
                          <a:solidFill>
                            <a:srgbClr val="000000"/>
                          </a:solidFill>
                        </a:rPr>
                        <a:t>caspases</a:t>
                      </a:r>
                      <a:r>
                        <a:rPr lang="de-DE" sz="1000" dirty="0" smtClean="0">
                          <a:solidFill>
                            <a:srgbClr val="000000"/>
                          </a:solidFill>
                        </a:rPr>
                        <a:t>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9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2.50e-05</a:t>
                      </a:r>
                    </a:p>
                    <a:p>
                      <a:pPr algn="ctr"/>
                      <a:endParaRPr lang="mr-IN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110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</a:rPr>
                        <a:t>HALLMARK_P53_PATHWAY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200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</a:rPr>
                        <a:t>Genes involved in p53 pathways and networks.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5</a:t>
                      </a:r>
                      <a:endParaRPr lang="de-DE" sz="10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mr-IN" sz="1000" dirty="0" smtClean="0">
                          <a:solidFill>
                            <a:srgbClr val="000000"/>
                          </a:solidFill>
                        </a:rPr>
                        <a:t>4.44e-02</a:t>
                      </a:r>
                      <a:endParaRPr lang="de-DE" sz="1000" dirty="0" smtClean="0">
                        <a:solidFill>
                          <a:srgbClr val="000000"/>
                        </a:solidFill>
                      </a:endParaRPr>
                    </a:p>
                    <a:p>
                      <a:pPr algn="ctr"/>
                      <a:endParaRPr lang="mr-IN" sz="1000" dirty="0">
                        <a:solidFill>
                          <a:srgbClr val="000000"/>
                        </a:solidFill>
                      </a:endParaRPr>
                    </a:p>
                  </a:txBody>
                  <a:tcPr marL="60960" marR="60960" marT="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0" y="-4719"/>
            <a:ext cx="14164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/>
                <a:cs typeface="Arial"/>
              </a:rPr>
              <a:t>Suppl</a:t>
            </a:r>
            <a:r>
              <a:rPr lang="de-DE" dirty="0" smtClean="0">
                <a:latin typeface="Arial"/>
                <a:cs typeface="Arial"/>
              </a:rPr>
              <a:t>. </a:t>
            </a:r>
            <a:r>
              <a:rPr lang="de-DE" dirty="0" err="1" smtClean="0">
                <a:latin typeface="Arial"/>
                <a:cs typeface="Arial"/>
              </a:rPr>
              <a:t>Fig</a:t>
            </a:r>
            <a:r>
              <a:rPr lang="de-DE" smtClean="0">
                <a:latin typeface="Arial"/>
                <a:cs typeface="Arial"/>
              </a:rPr>
              <a:t> </a:t>
            </a:r>
            <a:r>
              <a:rPr lang="de-DE" smtClean="0">
                <a:latin typeface="Arial"/>
                <a:cs typeface="Arial"/>
              </a:rPr>
              <a:t>4</a:t>
            </a:r>
            <a:endParaRPr lang="de-DE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373216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Standarddesign.thmx</Template>
  <TotalTime>0</TotalTime>
  <Words>290</Words>
  <Application>Microsoft Macintosh PowerPoint</Application>
  <PresentationFormat>Bildschirmpräsentation (4:3)</PresentationFormat>
  <Paragraphs>78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Standarddesign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ia Solovey</dc:creator>
  <cp:lastModifiedBy>Maria Solovey</cp:lastModifiedBy>
  <cp:revision>4</cp:revision>
  <dcterms:created xsi:type="dcterms:W3CDTF">2019-02-05T08:12:30Z</dcterms:created>
  <dcterms:modified xsi:type="dcterms:W3CDTF">2019-05-31T14:03:52Z</dcterms:modified>
</cp:coreProperties>
</file>